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FB4E3-3DFD-4C7B-A952-A9540A27A8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898957-54CE-46C7-9B5A-13D123A40D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801B0F-6F3E-4BCE-BFAB-D4E707DEE43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64B8A-D86D-494A-A856-7EDC382F02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BAF8C-85AC-4958-B082-AAB57BA6DB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AA03FB-046C-4161-B658-E5CE53F3EC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63D20-C0B9-4424-8F87-14BBA93920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2F7D8-80AA-4142-B27D-CCD78F17CA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6DA6C-77D0-452C-90CA-4CFAFFBB26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A07D3-9BA4-4945-8256-3A774AA524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8BCEA-EE69-4977-9CF9-673EC67143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763F00-E67B-4F76-964B-699C039E15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52E361-6CB8-4391-A30F-4AF224CE406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371600" y="1600200"/>
          <a:ext cx="4854240" cy="4341600"/>
        </p:xfrm>
        <a:graphic>
          <a:graphicData uri="http://schemas.openxmlformats.org/drawingml/2006/table">
            <a:tbl>
              <a:tblPr/>
              <a:tblGrid>
                <a:gridCol w="626760"/>
                <a:gridCol w="1227240"/>
                <a:gridCol w="1909440"/>
                <a:gridCol w="1090800"/>
              </a:tblGrid>
              <a:tr h="722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. No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nskrit 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otanical 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r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4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hay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erminalia chebul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ui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5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ibheetak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erminalia beleri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ui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5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malak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belica officinal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ui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5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aridr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rcuma lon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izo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22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ijaysa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terocarpus marsupiu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artwoo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218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ktachitrak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umbago indi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o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5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hadir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acia catechu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ar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1297080" y="1096920"/>
            <a:ext cx="242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1. Composition of Ka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Nitin Rola</cp:lastModifiedBy>
  <dcterms:modified xsi:type="dcterms:W3CDTF">2013-08-22T08:58:41Z</dcterms:modified>
  <cp:revision>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